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0760" autoAdjust="0"/>
  </p:normalViewPr>
  <p:slideViewPr>
    <p:cSldViewPr snapToGrid="0">
      <p:cViewPr varScale="1">
        <p:scale>
          <a:sx n="83" d="100"/>
          <a:sy n="83" d="100"/>
        </p:scale>
        <p:origin x="88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1689FF9-9FC0-47A5-B7EE-A96038E9DE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6B72955-79A2-4A66-9DD6-523EE93A4A0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D2AC290-C497-4CEE-B1FF-2148EE30A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BD6FE-E2DB-4ACA-BCCB-74DE388183AE}" type="datetimeFigureOut">
              <a:rPr lang="ko-KR" altLang="en-US" smtClean="0"/>
              <a:t>2022-04-2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14A746A-5A7C-491D-82DE-341EDEA92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A658F27-8D3C-42E1-80E9-083640DC2E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A8BD-2667-4CE6-B567-6A5EE7D66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05546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81CB912-37F9-454B-A72A-63F63D8B54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ECE63B0-E5AF-4BB2-8CAB-BE45641776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FBE766B-F241-4AD2-83FD-15C41735C7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BD6FE-E2DB-4ACA-BCCB-74DE388183AE}" type="datetimeFigureOut">
              <a:rPr lang="ko-KR" altLang="en-US" smtClean="0"/>
              <a:t>2022-04-2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DBBC505-E17E-4916-8C73-8FE010B1A2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00020C5-6904-4AC8-8F50-57F246F3F3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A8BD-2667-4CE6-B567-6A5EE7D66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9432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8756E1B9-A5E5-4BE2-B37C-F590CEE340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DBC6DA5C-2F47-4FF7-92C7-C1BAAE2D43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E09B86E-D525-45AC-AF80-70543FED57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BD6FE-E2DB-4ACA-BCCB-74DE388183AE}" type="datetimeFigureOut">
              <a:rPr lang="ko-KR" altLang="en-US" smtClean="0"/>
              <a:t>2022-04-2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6C4F676-FC0C-4FAE-B4E0-6C96294066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5AEF53D-1DC9-4EB9-8248-1F34FDC245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A8BD-2667-4CE6-B567-6A5EE7D66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2230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26A4C86-FF45-46F5-ABC1-9714675EDB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76F6AE4-DB72-45AA-80F9-7445BBAF13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3F28D49-2EB7-457E-8054-805683CE61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BD6FE-E2DB-4ACA-BCCB-74DE388183AE}" type="datetimeFigureOut">
              <a:rPr lang="ko-KR" altLang="en-US" smtClean="0"/>
              <a:t>2022-04-2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0BC62FB-54CD-4E9B-BBAF-471E4A7E9C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DB2D431-69A6-450C-93B3-4C5D8E4CB8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A8BD-2667-4CE6-B567-6A5EE7D66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24511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B7554A4-5560-4B46-A5B9-4B5581CDD3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5E24503-839A-4249-A38F-18D4A7663E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6DAA9B3-8C60-42CD-9DBE-0A09BE0DB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BD6FE-E2DB-4ACA-BCCB-74DE388183AE}" type="datetimeFigureOut">
              <a:rPr lang="ko-KR" altLang="en-US" smtClean="0"/>
              <a:t>2022-04-2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2CBE27C-41DF-4452-920B-34B6C06F42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A6190D1-B4DA-4DC6-905F-458D36EF6D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A8BD-2667-4CE6-B567-6A5EE7D66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170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9D58C5F-58D7-43B7-89DE-065666DC3A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1980DB2-0D53-46A6-92FC-D53F2547140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65A01C9-3449-4CD4-8661-7809B69B7A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7D0132A-9C3F-4F4B-A071-F0722DACB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BD6FE-E2DB-4ACA-BCCB-74DE388183AE}" type="datetimeFigureOut">
              <a:rPr lang="ko-KR" altLang="en-US" smtClean="0"/>
              <a:t>2022-04-2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3441ABB-9DF6-4047-A602-306C392818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BACCBC4-9BEF-45B1-A4F3-E0BA7CFAD2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A8BD-2667-4CE6-B567-6A5EE7D66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1523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044E971-1346-4670-A598-D2A0C07F0B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E5E111C-04BC-47A8-9881-6D43610A90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F0FB43FD-4807-4962-A6C9-49CFAE9CC0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71C89D4C-E3DE-4321-BCB5-F04367CC8B1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F9B5A962-E02A-4ED8-8FC8-7997F4ECB0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0380D739-73EE-47F9-8FC5-CE645CD85B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BD6FE-E2DB-4ACA-BCCB-74DE388183AE}" type="datetimeFigureOut">
              <a:rPr lang="ko-KR" altLang="en-US" smtClean="0"/>
              <a:t>2022-04-20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A4237AC4-D2C8-4293-BA21-5B46351D8F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794E88EF-9E72-49B6-9114-C8230C3759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A8BD-2667-4CE6-B567-6A5EE7D66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36426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746244F-9F28-4B33-BC22-FDD592F446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8E1968DC-3C10-4C98-88AF-1E1F2A157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BD6FE-E2DB-4ACA-BCCB-74DE388183AE}" type="datetimeFigureOut">
              <a:rPr lang="ko-KR" altLang="en-US" smtClean="0"/>
              <a:t>2022-04-2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3C350E56-ECB2-42BD-8F3B-46C3CFDDC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7339DBBF-0E0F-48D2-AD1A-D2F276F53A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A8BD-2667-4CE6-B567-6A5EE7D66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0891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FF1FE2F5-562E-40B0-9666-3768365CD7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BD6FE-E2DB-4ACA-BCCB-74DE388183AE}" type="datetimeFigureOut">
              <a:rPr lang="ko-KR" altLang="en-US" smtClean="0"/>
              <a:t>2022-04-20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89C19F1F-0533-4357-9EDC-F019D72A61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658D5451-64E2-414C-A94B-E1545FFA88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A8BD-2667-4CE6-B567-6A5EE7D66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6468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BAF7A5C-A130-48A2-9913-BF51DFC324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12C26BE-7DB8-420F-92F4-2FEBC24A6B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73E2438E-CA45-4231-BCA0-A726AFB710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CB26612-3D7D-44EE-8CD3-CA01F27591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BD6FE-E2DB-4ACA-BCCB-74DE388183AE}" type="datetimeFigureOut">
              <a:rPr lang="ko-KR" altLang="en-US" smtClean="0"/>
              <a:t>2022-04-2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54F8168-C3F0-4FC7-B93C-0F6D4A95CC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0161C85-9D5A-4D95-9BAB-08CD74CA3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A8BD-2667-4CE6-B567-6A5EE7D66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99911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926A183-4CBC-4E60-BE06-9919858A27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016F6967-4188-47B2-915F-0FF5676AA0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6621AC3C-5172-4DF6-B7A4-447F060182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F705E32E-89EC-4CB6-B1A0-E7C334A89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BD6FE-E2DB-4ACA-BCCB-74DE388183AE}" type="datetimeFigureOut">
              <a:rPr lang="ko-KR" altLang="en-US" smtClean="0"/>
              <a:t>2022-04-2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AB80429-07E7-45D6-A3DC-DF440FE24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80A4F1EF-A0C9-4495-8849-135CA756A1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44A8BD-2667-4CE6-B567-6A5EE7D66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97623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F8F5FF70-51FC-45A9-9BFC-10C28537FB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AB1090E-D479-46C8-9A1C-B0EF8C7D65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DA01F10-09EE-468E-97CC-3FD8AF09290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0BD6FE-E2DB-4ACA-BCCB-74DE388183AE}" type="datetimeFigureOut">
              <a:rPr lang="ko-KR" altLang="en-US" smtClean="0"/>
              <a:t>2022-04-2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3AC0663-B985-4DA1-98A7-B2FFFAAB29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DED400F-1901-48A8-B5E4-D359988D6B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44A8BD-2667-4CE6-B567-6A5EE7D66B8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51235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BFA73DF-81FD-4082-B7EC-8FC60CA5C03E}"/>
              </a:ext>
            </a:extLst>
          </p:cNvPr>
          <p:cNvSpPr txBox="1"/>
          <p:nvPr/>
        </p:nvSpPr>
        <p:spPr>
          <a:xfrm>
            <a:off x="251670" y="391817"/>
            <a:ext cx="43844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Calibri" panose="020F0502020204030204" pitchFamily="34" charset="0"/>
                <a:cs typeface="Calibri" panose="020F0502020204030204" pitchFamily="34" charset="0"/>
              </a:rPr>
              <a:t>Supp. Figure1. Overall Psychological </a:t>
            </a:r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D</a:t>
            </a:r>
            <a:r>
              <a:rPr lang="en-US" altLang="ko-KR" dirty="0" smtClean="0">
                <a:latin typeface="Calibri" panose="020F0502020204030204" pitchFamily="34" charset="0"/>
                <a:cs typeface="Calibri" panose="020F0502020204030204" pitchFamily="34" charset="0"/>
              </a:rPr>
              <a:t>isorder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5" name="표 4">
            <a:extLst>
              <a:ext uri="{FF2B5EF4-FFF2-40B4-BE49-F238E27FC236}">
                <a16:creationId xmlns:a16="http://schemas.microsoft.com/office/drawing/2014/main" id="{C6CB001C-0B20-41CF-88A8-354026A34F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0052880"/>
              </p:ext>
            </p:extLst>
          </p:nvPr>
        </p:nvGraphicFramePr>
        <p:xfrm>
          <a:off x="251671" y="993354"/>
          <a:ext cx="8079808" cy="176568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350015">
                  <a:extLst>
                    <a:ext uri="{9D8B030D-6E8A-4147-A177-3AD203B41FA5}">
                      <a16:colId xmlns:a16="http://schemas.microsoft.com/office/drawing/2014/main" val="3402208354"/>
                    </a:ext>
                  </a:extLst>
                </a:gridCol>
                <a:gridCol w="1415143">
                  <a:extLst>
                    <a:ext uri="{9D8B030D-6E8A-4147-A177-3AD203B41FA5}">
                      <a16:colId xmlns:a16="http://schemas.microsoft.com/office/drawing/2014/main" val="1653283407"/>
                    </a:ext>
                  </a:extLst>
                </a:gridCol>
                <a:gridCol w="1338942">
                  <a:extLst>
                    <a:ext uri="{9D8B030D-6E8A-4147-A177-3AD203B41FA5}">
                      <a16:colId xmlns:a16="http://schemas.microsoft.com/office/drawing/2014/main" val="3975621948"/>
                    </a:ext>
                  </a:extLst>
                </a:gridCol>
                <a:gridCol w="1491343">
                  <a:extLst>
                    <a:ext uri="{9D8B030D-6E8A-4147-A177-3AD203B41FA5}">
                      <a16:colId xmlns:a16="http://schemas.microsoft.com/office/drawing/2014/main" val="1160445444"/>
                    </a:ext>
                  </a:extLst>
                </a:gridCol>
                <a:gridCol w="1484365">
                  <a:extLst>
                    <a:ext uri="{9D8B030D-6E8A-4147-A177-3AD203B41FA5}">
                      <a16:colId xmlns:a16="http://schemas.microsoft.com/office/drawing/2014/main" val="4022707468"/>
                    </a:ext>
                  </a:extLst>
                </a:gridCol>
              </a:tblGrid>
              <a:tr h="403991">
                <a:tc rowSpan="2"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7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otal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7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M 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N=9394)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M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>
                    <a:solidFill>
                      <a:schemeClr val="accent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904799"/>
                  </a:ext>
                </a:extLst>
              </a:tr>
              <a:tr h="206565">
                <a:tc vMerge="1">
                  <a:txBody>
                    <a:bodyPr/>
                    <a:lstStyle/>
                    <a:p>
                      <a:pPr algn="just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M-RS(+) 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M-RS(-)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ko-KR" sz="10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80515017"/>
                  </a:ext>
                </a:extLst>
              </a:tr>
              <a:tr h="197425"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</a:t>
                      </a:r>
                      <a:endParaRPr lang="ko-KR" sz="14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6,259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=4,056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=5,338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=16,865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6557547"/>
                  </a:ext>
                </a:extLst>
              </a:tr>
              <a:tr h="197425"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verall psychological </a:t>
                      </a: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isorder</a:t>
                      </a:r>
                      <a:endParaRPr lang="ko-KR" sz="14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,685 (17.84%)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34 (15.63%)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,003 (18.79%)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,048 (18.07%)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3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7694870"/>
                  </a:ext>
                </a:extLst>
              </a:tr>
              <a:tr h="197425">
                <a:tc>
                  <a:txBody>
                    <a:bodyPr/>
                    <a:lstStyle/>
                    <a:p>
                      <a:pPr lvl="0" algn="l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      Depression</a:t>
                      </a:r>
                      <a:endParaRPr lang="ko-KR" sz="14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,464 (5.58%)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32 (5.72%)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08 (5.77%)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24 (5.48%)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9312505"/>
                  </a:ext>
                </a:extLst>
              </a:tr>
              <a:tr h="197425">
                <a:tc>
                  <a:txBody>
                    <a:bodyPr/>
                    <a:lstStyle/>
                    <a:p>
                      <a:pPr lvl="0" algn="l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400" kern="1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      </a:t>
                      </a: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nxiety disorder</a:t>
                      </a:r>
                      <a:endParaRPr lang="ko-KR" sz="14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,005 (7.64%)</a:t>
                      </a:r>
                      <a:endParaRPr lang="ko-KR" sz="14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80 (6.90%)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43 (8.30%)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,282 (7.60%)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9390306"/>
                  </a:ext>
                </a:extLst>
              </a:tr>
              <a:tr h="197425">
                <a:tc>
                  <a:txBody>
                    <a:bodyPr/>
                    <a:lstStyle/>
                    <a:p>
                      <a:pPr lvl="0" algn="l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      Insomnia</a:t>
                      </a:r>
                      <a:endParaRPr lang="ko-KR" sz="140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,611 (9.94%)</a:t>
                      </a:r>
                      <a:endParaRPr lang="ko-KR" sz="1400" kern="10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47 (8.56%)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55 (10.40%)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kern="1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,709 (10.13%)</a:t>
                      </a:r>
                      <a:endParaRPr lang="ko-KR" sz="1400" kern="100" dirty="0">
                        <a:effectLst/>
                        <a:latin typeface="Calibri" panose="020F0502020204030204" pitchFamily="34" charset="0"/>
                        <a:ea typeface="맑은 고딕" panose="020B0503020000020004" pitchFamily="50" charset="-127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7870024"/>
                  </a:ext>
                </a:extLst>
              </a:tr>
            </a:tbl>
          </a:graphicData>
        </a:graphic>
      </p:graphicFrame>
      <p:grpSp>
        <p:nvGrpSpPr>
          <p:cNvPr id="20" name="그룹 19">
            <a:extLst>
              <a:ext uri="{FF2B5EF4-FFF2-40B4-BE49-F238E27FC236}">
                <a16:creationId xmlns:a16="http://schemas.microsoft.com/office/drawing/2014/main" id="{20617ABB-2977-42B7-A742-3E7E9AABC287}"/>
              </a:ext>
            </a:extLst>
          </p:cNvPr>
          <p:cNvGrpSpPr/>
          <p:nvPr/>
        </p:nvGrpSpPr>
        <p:grpSpPr>
          <a:xfrm>
            <a:off x="8422119" y="850752"/>
            <a:ext cx="3475833" cy="2252444"/>
            <a:chOff x="2551296" y="2873232"/>
            <a:chExt cx="3475833" cy="2252444"/>
          </a:xfrm>
        </p:grpSpPr>
        <p:sp>
          <p:nvSpPr>
            <p:cNvPr id="6" name="타원 5">
              <a:extLst>
                <a:ext uri="{FF2B5EF4-FFF2-40B4-BE49-F238E27FC236}">
                  <a16:creationId xmlns:a16="http://schemas.microsoft.com/office/drawing/2014/main" id="{58190D35-B877-4F71-BEFC-179FB0E1DDD0}"/>
                </a:ext>
              </a:extLst>
            </p:cNvPr>
            <p:cNvSpPr/>
            <p:nvPr/>
          </p:nvSpPr>
          <p:spPr>
            <a:xfrm>
              <a:off x="3491918" y="2873232"/>
              <a:ext cx="1501200" cy="1501629"/>
            </a:xfrm>
            <a:prstGeom prst="ellipse">
              <a:avLst/>
            </a:prstGeom>
            <a:solidFill>
              <a:srgbClr val="4472C4">
                <a:alpha val="20000"/>
              </a:srgbClr>
            </a:solidFill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7" name="타원 6">
              <a:extLst>
                <a:ext uri="{FF2B5EF4-FFF2-40B4-BE49-F238E27FC236}">
                  <a16:creationId xmlns:a16="http://schemas.microsoft.com/office/drawing/2014/main" id="{7915515D-A9E8-4CAA-AF75-0FC324FBF0A2}"/>
                </a:ext>
              </a:extLst>
            </p:cNvPr>
            <p:cNvSpPr/>
            <p:nvPr/>
          </p:nvSpPr>
          <p:spPr>
            <a:xfrm>
              <a:off x="2954323" y="3624047"/>
              <a:ext cx="1501200" cy="1501629"/>
            </a:xfrm>
            <a:prstGeom prst="ellipse">
              <a:avLst/>
            </a:prstGeom>
            <a:solidFill>
              <a:schemeClr val="accent6">
                <a:lumMod val="60000"/>
                <a:lumOff val="40000"/>
                <a:alpha val="20000"/>
              </a:schemeClr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8" name="타원 7">
              <a:extLst>
                <a:ext uri="{FF2B5EF4-FFF2-40B4-BE49-F238E27FC236}">
                  <a16:creationId xmlns:a16="http://schemas.microsoft.com/office/drawing/2014/main" id="{0F045A73-287C-429E-90D4-DDF97C5B6302}"/>
                </a:ext>
              </a:extLst>
            </p:cNvPr>
            <p:cNvSpPr/>
            <p:nvPr/>
          </p:nvSpPr>
          <p:spPr>
            <a:xfrm>
              <a:off x="4029513" y="3624047"/>
              <a:ext cx="1501200" cy="1501629"/>
            </a:xfrm>
            <a:prstGeom prst="ellipse">
              <a:avLst/>
            </a:prstGeom>
            <a:solidFill>
              <a:schemeClr val="accent2">
                <a:lumMod val="60000"/>
                <a:lumOff val="40000"/>
                <a:alpha val="20000"/>
              </a:schemeClr>
            </a:solidFill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142615D-0F24-43D2-8A68-B8A8337A42D5}"/>
                </a:ext>
              </a:extLst>
            </p:cNvPr>
            <p:cNvSpPr txBox="1"/>
            <p:nvPr/>
          </p:nvSpPr>
          <p:spPr>
            <a:xfrm>
              <a:off x="3750193" y="2899704"/>
              <a:ext cx="10178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solidFill>
                    <a:schemeClr val="accent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Depression</a:t>
              </a:r>
              <a:endParaRPr lang="ko-KR" altLang="en-US" sz="1400" b="1" dirty="0">
                <a:solidFill>
                  <a:schemeClr val="accent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C99F60B-EA1E-4988-8514-826D077303F9}"/>
                </a:ext>
              </a:extLst>
            </p:cNvPr>
            <p:cNvSpPr txBox="1"/>
            <p:nvPr/>
          </p:nvSpPr>
          <p:spPr>
            <a:xfrm>
              <a:off x="2551296" y="4247475"/>
              <a:ext cx="80605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solidFill>
                    <a:schemeClr val="accent6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Anxiety </a:t>
              </a:r>
              <a:br>
                <a:rPr lang="en-US" altLang="ko-KR" sz="1400" b="1" dirty="0">
                  <a:solidFill>
                    <a:schemeClr val="accent6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</a:br>
              <a:r>
                <a:rPr lang="en-US" altLang="ko-KR" sz="1400" b="1" dirty="0">
                  <a:solidFill>
                    <a:schemeClr val="accent6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disorder</a:t>
              </a:r>
              <a:endParaRPr lang="ko-KR" altLang="en-US" sz="1400" b="1" dirty="0">
                <a:solidFill>
                  <a:schemeClr val="accent6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2A488F4-3A7F-4980-AB21-8FCF2A8B4AFF}"/>
                </a:ext>
              </a:extLst>
            </p:cNvPr>
            <p:cNvSpPr txBox="1"/>
            <p:nvPr/>
          </p:nvSpPr>
          <p:spPr>
            <a:xfrm>
              <a:off x="5154774" y="4113251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solidFill>
                    <a:schemeClr val="accent2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Insomnia</a:t>
              </a:r>
              <a:endParaRPr lang="ko-KR" altLang="en-US" sz="1400" b="1" dirty="0">
                <a:solidFill>
                  <a:schemeClr val="accent2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6B51C57-12FB-428C-8B03-A55046E55C47}"/>
                </a:ext>
              </a:extLst>
            </p:cNvPr>
            <p:cNvSpPr txBox="1"/>
            <p:nvPr/>
          </p:nvSpPr>
          <p:spPr>
            <a:xfrm>
              <a:off x="4008724" y="4025139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252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40DB6A2-02DA-43AE-A920-F44C394326CF}"/>
                </a:ext>
              </a:extLst>
            </p:cNvPr>
            <p:cNvSpPr txBox="1"/>
            <p:nvPr/>
          </p:nvSpPr>
          <p:spPr>
            <a:xfrm>
              <a:off x="3996743" y="3280100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677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320EB42-985B-455D-B025-0BF6798D7EF7}"/>
                </a:ext>
              </a:extLst>
            </p:cNvPr>
            <p:cNvSpPr txBox="1"/>
            <p:nvPr/>
          </p:nvSpPr>
          <p:spPr>
            <a:xfrm>
              <a:off x="3315996" y="4332129"/>
              <a:ext cx="5950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1,119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E2F1F01-288A-4179-8BD5-E53C9A059CE6}"/>
                </a:ext>
              </a:extLst>
            </p:cNvPr>
            <p:cNvSpPr txBox="1"/>
            <p:nvPr/>
          </p:nvSpPr>
          <p:spPr>
            <a:xfrm>
              <a:off x="4574006" y="4315622"/>
              <a:ext cx="5950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1,746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FC3DE3E-8E6A-4C4A-BFDD-D6CD4D926FE5}"/>
                </a:ext>
              </a:extLst>
            </p:cNvPr>
            <p:cNvSpPr txBox="1"/>
            <p:nvPr/>
          </p:nvSpPr>
          <p:spPr>
            <a:xfrm>
              <a:off x="3704923" y="3800740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278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34474A8-C4BB-402D-B6F9-FAF06D4D1EEC}"/>
                </a:ext>
              </a:extLst>
            </p:cNvPr>
            <p:cNvSpPr txBox="1"/>
            <p:nvPr/>
          </p:nvSpPr>
          <p:spPr>
            <a:xfrm>
              <a:off x="4399770" y="3800740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257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7EC9B9C-E557-45AB-84E3-F9CE8524DB11}"/>
                </a:ext>
              </a:extLst>
            </p:cNvPr>
            <p:cNvSpPr txBox="1"/>
            <p:nvPr/>
          </p:nvSpPr>
          <p:spPr>
            <a:xfrm>
              <a:off x="4001671" y="4387447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356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C6D8CB90-79E7-4A69-BE12-669DF989F123}"/>
              </a:ext>
            </a:extLst>
          </p:cNvPr>
          <p:cNvSpPr txBox="1"/>
          <p:nvPr/>
        </p:nvSpPr>
        <p:spPr>
          <a:xfrm>
            <a:off x="9820418" y="317318"/>
            <a:ext cx="649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Total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22" name="그룹 21">
            <a:extLst>
              <a:ext uri="{FF2B5EF4-FFF2-40B4-BE49-F238E27FC236}">
                <a16:creationId xmlns:a16="http://schemas.microsoft.com/office/drawing/2014/main" id="{EFCE406A-FE04-4AB8-B6CE-06DE9BE16875}"/>
              </a:ext>
            </a:extLst>
          </p:cNvPr>
          <p:cNvGrpSpPr/>
          <p:nvPr/>
        </p:nvGrpSpPr>
        <p:grpSpPr>
          <a:xfrm>
            <a:off x="353308" y="4022524"/>
            <a:ext cx="3475833" cy="2252444"/>
            <a:chOff x="2551296" y="2873232"/>
            <a:chExt cx="3475833" cy="2252444"/>
          </a:xfrm>
        </p:grpSpPr>
        <p:sp>
          <p:nvSpPr>
            <p:cNvPr id="23" name="타원 22">
              <a:extLst>
                <a:ext uri="{FF2B5EF4-FFF2-40B4-BE49-F238E27FC236}">
                  <a16:creationId xmlns:a16="http://schemas.microsoft.com/office/drawing/2014/main" id="{20A577F2-063D-4F98-88A7-B8579552C894}"/>
                </a:ext>
              </a:extLst>
            </p:cNvPr>
            <p:cNvSpPr/>
            <p:nvPr/>
          </p:nvSpPr>
          <p:spPr>
            <a:xfrm>
              <a:off x="3491918" y="2873232"/>
              <a:ext cx="1501200" cy="1501629"/>
            </a:xfrm>
            <a:prstGeom prst="ellipse">
              <a:avLst/>
            </a:prstGeom>
            <a:solidFill>
              <a:srgbClr val="4472C4">
                <a:alpha val="20000"/>
              </a:srgbClr>
            </a:solidFill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24" name="타원 23">
              <a:extLst>
                <a:ext uri="{FF2B5EF4-FFF2-40B4-BE49-F238E27FC236}">
                  <a16:creationId xmlns:a16="http://schemas.microsoft.com/office/drawing/2014/main" id="{2D34909D-FB27-42C1-8F25-7BE00D42912B}"/>
                </a:ext>
              </a:extLst>
            </p:cNvPr>
            <p:cNvSpPr/>
            <p:nvPr/>
          </p:nvSpPr>
          <p:spPr>
            <a:xfrm>
              <a:off x="2954323" y="3624047"/>
              <a:ext cx="1501200" cy="1501629"/>
            </a:xfrm>
            <a:prstGeom prst="ellipse">
              <a:avLst/>
            </a:prstGeom>
            <a:solidFill>
              <a:schemeClr val="accent6">
                <a:lumMod val="60000"/>
                <a:lumOff val="40000"/>
                <a:alpha val="20000"/>
              </a:schemeClr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25" name="타원 24">
              <a:extLst>
                <a:ext uri="{FF2B5EF4-FFF2-40B4-BE49-F238E27FC236}">
                  <a16:creationId xmlns:a16="http://schemas.microsoft.com/office/drawing/2014/main" id="{09781EBE-76A3-4B32-82AE-B113D15931FE}"/>
                </a:ext>
              </a:extLst>
            </p:cNvPr>
            <p:cNvSpPr/>
            <p:nvPr/>
          </p:nvSpPr>
          <p:spPr>
            <a:xfrm>
              <a:off x="4029513" y="3624047"/>
              <a:ext cx="1501200" cy="1501629"/>
            </a:xfrm>
            <a:prstGeom prst="ellipse">
              <a:avLst/>
            </a:prstGeom>
            <a:solidFill>
              <a:schemeClr val="accent2">
                <a:lumMod val="60000"/>
                <a:lumOff val="40000"/>
                <a:alpha val="20000"/>
              </a:schemeClr>
            </a:solidFill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DBAA6D9-4BE3-4D06-95A3-6862CFE9F335}"/>
                </a:ext>
              </a:extLst>
            </p:cNvPr>
            <p:cNvSpPr txBox="1"/>
            <p:nvPr/>
          </p:nvSpPr>
          <p:spPr>
            <a:xfrm>
              <a:off x="3750193" y="2899704"/>
              <a:ext cx="10178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solidFill>
                    <a:schemeClr val="accent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Depression</a:t>
              </a:r>
              <a:endParaRPr lang="ko-KR" altLang="en-US" sz="1400" b="1" dirty="0">
                <a:solidFill>
                  <a:schemeClr val="accent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EBAC5F6-05D3-4F6C-8C6F-A26B595A3BCA}"/>
                </a:ext>
              </a:extLst>
            </p:cNvPr>
            <p:cNvSpPr txBox="1"/>
            <p:nvPr/>
          </p:nvSpPr>
          <p:spPr>
            <a:xfrm>
              <a:off x="2551296" y="4247475"/>
              <a:ext cx="80605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solidFill>
                    <a:schemeClr val="accent6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Anxiety </a:t>
              </a:r>
              <a:br>
                <a:rPr lang="en-US" altLang="ko-KR" sz="1400" b="1" dirty="0">
                  <a:solidFill>
                    <a:schemeClr val="accent6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</a:br>
              <a:r>
                <a:rPr lang="en-US" altLang="ko-KR" sz="1400" b="1" dirty="0">
                  <a:solidFill>
                    <a:schemeClr val="accent6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disorder</a:t>
              </a:r>
              <a:endParaRPr lang="ko-KR" altLang="en-US" sz="1400" b="1" dirty="0">
                <a:solidFill>
                  <a:schemeClr val="accent6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BD7F1E7-A8CB-4677-84C4-7158C5D99DDE}"/>
                </a:ext>
              </a:extLst>
            </p:cNvPr>
            <p:cNvSpPr txBox="1"/>
            <p:nvPr/>
          </p:nvSpPr>
          <p:spPr>
            <a:xfrm>
              <a:off x="5154774" y="4113251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solidFill>
                    <a:schemeClr val="accent2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Insomnia</a:t>
              </a:r>
              <a:endParaRPr lang="ko-KR" altLang="en-US" sz="1400" b="1" dirty="0">
                <a:solidFill>
                  <a:schemeClr val="accent2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D905B70-2006-42B4-B272-20AB90E93B85}"/>
                </a:ext>
              </a:extLst>
            </p:cNvPr>
            <p:cNvSpPr txBox="1"/>
            <p:nvPr/>
          </p:nvSpPr>
          <p:spPr>
            <a:xfrm>
              <a:off x="4054410" y="4025139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49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4CB347BD-B48E-4038-B9F0-8CF8D4463047}"/>
                </a:ext>
              </a:extLst>
            </p:cNvPr>
            <p:cNvSpPr txBox="1"/>
            <p:nvPr/>
          </p:nvSpPr>
          <p:spPr>
            <a:xfrm>
              <a:off x="3996743" y="3280100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103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D42A2A6-2897-49F7-B7D0-1A019F6A3F31}"/>
                </a:ext>
              </a:extLst>
            </p:cNvPr>
            <p:cNvSpPr txBox="1"/>
            <p:nvPr/>
          </p:nvSpPr>
          <p:spPr>
            <a:xfrm>
              <a:off x="3384124" y="4332129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138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909CF442-2E48-4F84-8A9A-69B066118B4B}"/>
                </a:ext>
              </a:extLst>
            </p:cNvPr>
            <p:cNvSpPr txBox="1"/>
            <p:nvPr/>
          </p:nvSpPr>
          <p:spPr>
            <a:xfrm>
              <a:off x="4642134" y="4315622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217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CAD041EC-B509-4342-8373-FEBE9D861860}"/>
                </a:ext>
              </a:extLst>
            </p:cNvPr>
            <p:cNvSpPr txBox="1"/>
            <p:nvPr/>
          </p:nvSpPr>
          <p:spPr>
            <a:xfrm>
              <a:off x="3750609" y="3800740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46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14732086-6094-4B32-A959-06B3B077CCFC}"/>
                </a:ext>
              </a:extLst>
            </p:cNvPr>
            <p:cNvSpPr txBox="1"/>
            <p:nvPr/>
          </p:nvSpPr>
          <p:spPr>
            <a:xfrm>
              <a:off x="4445456" y="3800740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34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3C077B3-B3FC-49AA-86C6-BD633AAE1B9F}"/>
                </a:ext>
              </a:extLst>
            </p:cNvPr>
            <p:cNvSpPr txBox="1"/>
            <p:nvPr/>
          </p:nvSpPr>
          <p:spPr>
            <a:xfrm>
              <a:off x="4047357" y="4387447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47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808D5C2D-21E2-4245-8E4D-FA8CB8542892}"/>
              </a:ext>
            </a:extLst>
          </p:cNvPr>
          <p:cNvSpPr txBox="1"/>
          <p:nvPr/>
        </p:nvSpPr>
        <p:spPr>
          <a:xfrm>
            <a:off x="1553101" y="3490699"/>
            <a:ext cx="1048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TM-RS(+)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37" name="그룹 36">
            <a:extLst>
              <a:ext uri="{FF2B5EF4-FFF2-40B4-BE49-F238E27FC236}">
                <a16:creationId xmlns:a16="http://schemas.microsoft.com/office/drawing/2014/main" id="{90B431F4-4FF7-4D3D-AB3D-D6460F17B785}"/>
              </a:ext>
            </a:extLst>
          </p:cNvPr>
          <p:cNvGrpSpPr/>
          <p:nvPr/>
        </p:nvGrpSpPr>
        <p:grpSpPr>
          <a:xfrm>
            <a:off x="4162970" y="4022524"/>
            <a:ext cx="3475833" cy="2252444"/>
            <a:chOff x="2551296" y="2873232"/>
            <a:chExt cx="3475833" cy="2252444"/>
          </a:xfrm>
        </p:grpSpPr>
        <p:sp>
          <p:nvSpPr>
            <p:cNvPr id="38" name="타원 37">
              <a:extLst>
                <a:ext uri="{FF2B5EF4-FFF2-40B4-BE49-F238E27FC236}">
                  <a16:creationId xmlns:a16="http://schemas.microsoft.com/office/drawing/2014/main" id="{DB7818D7-9E7F-4697-9F29-77A77C1EF96D}"/>
                </a:ext>
              </a:extLst>
            </p:cNvPr>
            <p:cNvSpPr/>
            <p:nvPr/>
          </p:nvSpPr>
          <p:spPr>
            <a:xfrm>
              <a:off x="3491918" y="2873232"/>
              <a:ext cx="1501200" cy="1501629"/>
            </a:xfrm>
            <a:prstGeom prst="ellipse">
              <a:avLst/>
            </a:prstGeom>
            <a:solidFill>
              <a:srgbClr val="4472C4">
                <a:alpha val="20000"/>
              </a:srgbClr>
            </a:solidFill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39" name="타원 38">
              <a:extLst>
                <a:ext uri="{FF2B5EF4-FFF2-40B4-BE49-F238E27FC236}">
                  <a16:creationId xmlns:a16="http://schemas.microsoft.com/office/drawing/2014/main" id="{79478022-22D1-4752-A05E-38AE1160C089}"/>
                </a:ext>
              </a:extLst>
            </p:cNvPr>
            <p:cNvSpPr/>
            <p:nvPr/>
          </p:nvSpPr>
          <p:spPr>
            <a:xfrm>
              <a:off x="2954323" y="3624047"/>
              <a:ext cx="1501200" cy="1501629"/>
            </a:xfrm>
            <a:prstGeom prst="ellipse">
              <a:avLst/>
            </a:prstGeom>
            <a:solidFill>
              <a:schemeClr val="accent6">
                <a:lumMod val="60000"/>
                <a:lumOff val="40000"/>
                <a:alpha val="20000"/>
              </a:schemeClr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40" name="타원 39">
              <a:extLst>
                <a:ext uri="{FF2B5EF4-FFF2-40B4-BE49-F238E27FC236}">
                  <a16:creationId xmlns:a16="http://schemas.microsoft.com/office/drawing/2014/main" id="{1A94C1E0-9F2A-4559-ADFA-866424784DC5}"/>
                </a:ext>
              </a:extLst>
            </p:cNvPr>
            <p:cNvSpPr/>
            <p:nvPr/>
          </p:nvSpPr>
          <p:spPr>
            <a:xfrm>
              <a:off x="4029513" y="3624047"/>
              <a:ext cx="1501200" cy="1501629"/>
            </a:xfrm>
            <a:prstGeom prst="ellipse">
              <a:avLst/>
            </a:prstGeom>
            <a:solidFill>
              <a:schemeClr val="accent2">
                <a:lumMod val="60000"/>
                <a:lumOff val="40000"/>
                <a:alpha val="20000"/>
              </a:schemeClr>
            </a:solidFill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9CFEB372-E0EA-46E1-AD43-4EFBCA754651}"/>
                </a:ext>
              </a:extLst>
            </p:cNvPr>
            <p:cNvSpPr txBox="1"/>
            <p:nvPr/>
          </p:nvSpPr>
          <p:spPr>
            <a:xfrm>
              <a:off x="3750193" y="2899704"/>
              <a:ext cx="10178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solidFill>
                    <a:schemeClr val="accent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Depression</a:t>
              </a:r>
              <a:endParaRPr lang="ko-KR" altLang="en-US" sz="1400" b="1" dirty="0">
                <a:solidFill>
                  <a:schemeClr val="accent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DEFB1EFB-BB05-4D5C-B129-2DAA24F6E51E}"/>
                </a:ext>
              </a:extLst>
            </p:cNvPr>
            <p:cNvSpPr txBox="1"/>
            <p:nvPr/>
          </p:nvSpPr>
          <p:spPr>
            <a:xfrm>
              <a:off x="2551296" y="4247475"/>
              <a:ext cx="80605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solidFill>
                    <a:schemeClr val="accent6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Anxiety </a:t>
              </a:r>
              <a:br>
                <a:rPr lang="en-US" altLang="ko-KR" sz="1400" b="1" dirty="0">
                  <a:solidFill>
                    <a:schemeClr val="accent6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</a:br>
              <a:r>
                <a:rPr lang="en-US" altLang="ko-KR" sz="1400" b="1" dirty="0">
                  <a:solidFill>
                    <a:schemeClr val="accent6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disorder</a:t>
              </a:r>
              <a:endParaRPr lang="ko-KR" altLang="en-US" sz="1400" b="1" dirty="0">
                <a:solidFill>
                  <a:schemeClr val="accent6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1F26EE38-F503-4603-A5A1-74E6742C9957}"/>
                </a:ext>
              </a:extLst>
            </p:cNvPr>
            <p:cNvSpPr txBox="1"/>
            <p:nvPr/>
          </p:nvSpPr>
          <p:spPr>
            <a:xfrm>
              <a:off x="5154774" y="4113251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solidFill>
                    <a:schemeClr val="accent2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Insomnia</a:t>
              </a:r>
              <a:endParaRPr lang="ko-KR" altLang="en-US" sz="1400" b="1" dirty="0">
                <a:solidFill>
                  <a:schemeClr val="accent2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7E8E31A-DE5A-4D2B-8B78-C5ED53B483FF}"/>
                </a:ext>
              </a:extLst>
            </p:cNvPr>
            <p:cNvSpPr txBox="1"/>
            <p:nvPr/>
          </p:nvSpPr>
          <p:spPr>
            <a:xfrm>
              <a:off x="4054410" y="4025139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49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B8A9D7C-9AF8-44FF-9732-6B62FB834A4E}"/>
                </a:ext>
              </a:extLst>
            </p:cNvPr>
            <p:cNvSpPr txBox="1"/>
            <p:nvPr/>
          </p:nvSpPr>
          <p:spPr>
            <a:xfrm>
              <a:off x="3996743" y="3280100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135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2080DC7-1697-43A1-B5DE-A572FBCFE875}"/>
                </a:ext>
              </a:extLst>
            </p:cNvPr>
            <p:cNvSpPr txBox="1"/>
            <p:nvPr/>
          </p:nvSpPr>
          <p:spPr>
            <a:xfrm>
              <a:off x="3384124" y="4332129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245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921D9B0F-CBC5-444C-9A0C-586F3BBB950D}"/>
                </a:ext>
              </a:extLst>
            </p:cNvPr>
            <p:cNvSpPr txBox="1"/>
            <p:nvPr/>
          </p:nvSpPr>
          <p:spPr>
            <a:xfrm>
              <a:off x="4642134" y="4315622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369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A80A42F6-CFB0-45EF-AF63-AA42C1AA0D82}"/>
                </a:ext>
              </a:extLst>
            </p:cNvPr>
            <p:cNvSpPr txBox="1"/>
            <p:nvPr/>
          </p:nvSpPr>
          <p:spPr>
            <a:xfrm>
              <a:off x="3750609" y="3800740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68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C33BEB5C-067A-49C3-9CFE-9399A6294FEF}"/>
                </a:ext>
              </a:extLst>
            </p:cNvPr>
            <p:cNvSpPr txBox="1"/>
            <p:nvPr/>
          </p:nvSpPr>
          <p:spPr>
            <a:xfrm>
              <a:off x="4445456" y="3800740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56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A2905CD9-D4B9-4DAA-A425-82B35CBCC5BF}"/>
                </a:ext>
              </a:extLst>
            </p:cNvPr>
            <p:cNvSpPr txBox="1"/>
            <p:nvPr/>
          </p:nvSpPr>
          <p:spPr>
            <a:xfrm>
              <a:off x="4047357" y="4387447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81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51" name="TextBox 50">
            <a:extLst>
              <a:ext uri="{FF2B5EF4-FFF2-40B4-BE49-F238E27FC236}">
                <a16:creationId xmlns:a16="http://schemas.microsoft.com/office/drawing/2014/main" id="{50620B28-716D-4A11-A28E-14F621BBEC12}"/>
              </a:ext>
            </a:extLst>
          </p:cNvPr>
          <p:cNvSpPr txBox="1"/>
          <p:nvPr/>
        </p:nvSpPr>
        <p:spPr>
          <a:xfrm>
            <a:off x="5335810" y="3462451"/>
            <a:ext cx="1003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TM-RS(-)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52" name="그룹 51">
            <a:extLst>
              <a:ext uri="{FF2B5EF4-FFF2-40B4-BE49-F238E27FC236}">
                <a16:creationId xmlns:a16="http://schemas.microsoft.com/office/drawing/2014/main" id="{78C2D39F-0543-45C5-BB1F-B34CD3FC74AE}"/>
              </a:ext>
            </a:extLst>
          </p:cNvPr>
          <p:cNvGrpSpPr/>
          <p:nvPr/>
        </p:nvGrpSpPr>
        <p:grpSpPr>
          <a:xfrm>
            <a:off x="8414489" y="3962434"/>
            <a:ext cx="3475833" cy="2252444"/>
            <a:chOff x="2551296" y="2873232"/>
            <a:chExt cx="3475833" cy="2252444"/>
          </a:xfrm>
        </p:grpSpPr>
        <p:sp>
          <p:nvSpPr>
            <p:cNvPr id="53" name="타원 52">
              <a:extLst>
                <a:ext uri="{FF2B5EF4-FFF2-40B4-BE49-F238E27FC236}">
                  <a16:creationId xmlns:a16="http://schemas.microsoft.com/office/drawing/2014/main" id="{43901049-53AA-4739-9A67-23D4530517F6}"/>
                </a:ext>
              </a:extLst>
            </p:cNvPr>
            <p:cNvSpPr/>
            <p:nvPr/>
          </p:nvSpPr>
          <p:spPr>
            <a:xfrm>
              <a:off x="3491918" y="2873232"/>
              <a:ext cx="1501200" cy="1501629"/>
            </a:xfrm>
            <a:prstGeom prst="ellipse">
              <a:avLst/>
            </a:prstGeom>
            <a:solidFill>
              <a:srgbClr val="4472C4">
                <a:alpha val="20000"/>
              </a:srgbClr>
            </a:solidFill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54" name="타원 53">
              <a:extLst>
                <a:ext uri="{FF2B5EF4-FFF2-40B4-BE49-F238E27FC236}">
                  <a16:creationId xmlns:a16="http://schemas.microsoft.com/office/drawing/2014/main" id="{2569A81C-D19F-4AF2-96DB-63712FDB2DFB}"/>
                </a:ext>
              </a:extLst>
            </p:cNvPr>
            <p:cNvSpPr/>
            <p:nvPr/>
          </p:nvSpPr>
          <p:spPr>
            <a:xfrm>
              <a:off x="2954323" y="3624047"/>
              <a:ext cx="1501200" cy="1501629"/>
            </a:xfrm>
            <a:prstGeom prst="ellipse">
              <a:avLst/>
            </a:prstGeom>
            <a:solidFill>
              <a:schemeClr val="accent6">
                <a:lumMod val="60000"/>
                <a:lumOff val="40000"/>
                <a:alpha val="20000"/>
              </a:schemeClr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55" name="타원 54">
              <a:extLst>
                <a:ext uri="{FF2B5EF4-FFF2-40B4-BE49-F238E27FC236}">
                  <a16:creationId xmlns:a16="http://schemas.microsoft.com/office/drawing/2014/main" id="{E661B0EF-0ADC-42DB-9E5F-D3306C00F72D}"/>
                </a:ext>
              </a:extLst>
            </p:cNvPr>
            <p:cNvSpPr/>
            <p:nvPr/>
          </p:nvSpPr>
          <p:spPr>
            <a:xfrm>
              <a:off x="4029513" y="3624047"/>
              <a:ext cx="1501200" cy="1501629"/>
            </a:xfrm>
            <a:prstGeom prst="ellipse">
              <a:avLst/>
            </a:prstGeom>
            <a:solidFill>
              <a:schemeClr val="accent2">
                <a:lumMod val="60000"/>
                <a:lumOff val="40000"/>
                <a:alpha val="20000"/>
              </a:schemeClr>
            </a:solidFill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B227D274-5471-4924-877A-17D988FAA2C1}"/>
                </a:ext>
              </a:extLst>
            </p:cNvPr>
            <p:cNvSpPr txBox="1"/>
            <p:nvPr/>
          </p:nvSpPr>
          <p:spPr>
            <a:xfrm>
              <a:off x="3750193" y="2899704"/>
              <a:ext cx="10178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solidFill>
                    <a:schemeClr val="accent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Depression</a:t>
              </a:r>
              <a:endParaRPr lang="ko-KR" altLang="en-US" sz="1400" b="1" dirty="0">
                <a:solidFill>
                  <a:schemeClr val="accent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B7972213-AF9F-47DA-87B3-CDA48A52321C}"/>
                </a:ext>
              </a:extLst>
            </p:cNvPr>
            <p:cNvSpPr txBox="1"/>
            <p:nvPr/>
          </p:nvSpPr>
          <p:spPr>
            <a:xfrm>
              <a:off x="2551296" y="4247475"/>
              <a:ext cx="806054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solidFill>
                    <a:schemeClr val="accent6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Anxiety </a:t>
              </a:r>
              <a:br>
                <a:rPr lang="en-US" altLang="ko-KR" sz="1400" b="1" dirty="0">
                  <a:solidFill>
                    <a:schemeClr val="accent6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</a:br>
              <a:r>
                <a:rPr lang="en-US" altLang="ko-KR" sz="1400" b="1" dirty="0">
                  <a:solidFill>
                    <a:schemeClr val="accent6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disorder</a:t>
              </a:r>
              <a:endParaRPr lang="ko-KR" altLang="en-US" sz="1400" b="1" dirty="0">
                <a:solidFill>
                  <a:schemeClr val="accent6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E16967C5-3E74-4DFE-A73D-7ECE7938F9C7}"/>
                </a:ext>
              </a:extLst>
            </p:cNvPr>
            <p:cNvSpPr txBox="1"/>
            <p:nvPr/>
          </p:nvSpPr>
          <p:spPr>
            <a:xfrm>
              <a:off x="5154774" y="4113251"/>
              <a:ext cx="8723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solidFill>
                    <a:schemeClr val="accent2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Insomnia</a:t>
              </a:r>
              <a:endParaRPr lang="ko-KR" altLang="en-US" sz="1400" b="1" dirty="0">
                <a:solidFill>
                  <a:schemeClr val="accent2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503A3473-BE01-47B4-B1C2-440CF9D9AF32}"/>
                </a:ext>
              </a:extLst>
            </p:cNvPr>
            <p:cNvSpPr txBox="1"/>
            <p:nvPr/>
          </p:nvSpPr>
          <p:spPr>
            <a:xfrm>
              <a:off x="4008724" y="4025139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154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E685FD7-1F46-4EA8-933E-0972C0102809}"/>
                </a:ext>
              </a:extLst>
            </p:cNvPr>
            <p:cNvSpPr txBox="1"/>
            <p:nvPr/>
          </p:nvSpPr>
          <p:spPr>
            <a:xfrm>
              <a:off x="3996744" y="3280100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439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2D95490E-74F0-441D-AAD7-75F6DE994E11}"/>
                </a:ext>
              </a:extLst>
            </p:cNvPr>
            <p:cNvSpPr txBox="1"/>
            <p:nvPr/>
          </p:nvSpPr>
          <p:spPr>
            <a:xfrm>
              <a:off x="3384124" y="4332129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736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CB201B6D-DEA3-4AA1-833B-FD56099C0AEA}"/>
                </a:ext>
              </a:extLst>
            </p:cNvPr>
            <p:cNvSpPr txBox="1"/>
            <p:nvPr/>
          </p:nvSpPr>
          <p:spPr>
            <a:xfrm>
              <a:off x="4574006" y="4315622"/>
              <a:ext cx="5950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1,160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B6C0B510-8D0B-499C-B913-B22281547CE2}"/>
                </a:ext>
              </a:extLst>
            </p:cNvPr>
            <p:cNvSpPr txBox="1"/>
            <p:nvPr/>
          </p:nvSpPr>
          <p:spPr>
            <a:xfrm>
              <a:off x="3704923" y="3800740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164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A95EDAB5-4C26-46FD-B6F6-7D64FE36941B}"/>
                </a:ext>
              </a:extLst>
            </p:cNvPr>
            <p:cNvSpPr txBox="1"/>
            <p:nvPr/>
          </p:nvSpPr>
          <p:spPr>
            <a:xfrm>
              <a:off x="4399770" y="3800740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167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BE0CBED9-3D39-4041-8146-3044FC2F9C4D}"/>
                </a:ext>
              </a:extLst>
            </p:cNvPr>
            <p:cNvSpPr txBox="1"/>
            <p:nvPr/>
          </p:nvSpPr>
          <p:spPr>
            <a:xfrm>
              <a:off x="4001671" y="4387447"/>
              <a:ext cx="4587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228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66" name="TextBox 65">
            <a:extLst>
              <a:ext uri="{FF2B5EF4-FFF2-40B4-BE49-F238E27FC236}">
                <a16:creationId xmlns:a16="http://schemas.microsoft.com/office/drawing/2014/main" id="{BE9C8DC4-0001-410A-8303-C36F5097BECB}"/>
              </a:ext>
            </a:extLst>
          </p:cNvPr>
          <p:cNvSpPr txBox="1"/>
          <p:nvPr/>
        </p:nvSpPr>
        <p:spPr>
          <a:xfrm>
            <a:off x="9812788" y="3429000"/>
            <a:ext cx="5004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Calibri" panose="020F0502020204030204" pitchFamily="34" charset="0"/>
                <a:cs typeface="Calibri" panose="020F0502020204030204" pitchFamily="34" charset="0"/>
              </a:rPr>
              <a:t>PM</a:t>
            </a:r>
            <a:endParaRPr lang="ko-KR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68" name="직선 연결선 67">
            <a:extLst>
              <a:ext uri="{FF2B5EF4-FFF2-40B4-BE49-F238E27FC236}">
                <a16:creationId xmlns:a16="http://schemas.microsoft.com/office/drawing/2014/main" id="{A9372387-A157-472E-A3C2-1B1732F14F43}"/>
              </a:ext>
            </a:extLst>
          </p:cNvPr>
          <p:cNvCxnSpPr/>
          <p:nvPr/>
        </p:nvCxnSpPr>
        <p:spPr>
          <a:xfrm>
            <a:off x="251670" y="3405931"/>
            <a:ext cx="1175297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235940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</TotalTime>
  <Words>155</Words>
  <Application>Microsoft Office PowerPoint</Application>
  <PresentationFormat>Widescreen</PresentationFormat>
  <Paragraphs>8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Calibri</vt:lpstr>
      <vt:lpstr>Office 테마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BRMH</dc:creator>
  <cp:lastModifiedBy>World Journal of Surgery</cp:lastModifiedBy>
  <cp:revision>6</cp:revision>
  <dcterms:created xsi:type="dcterms:W3CDTF">2022-01-26T02:04:02Z</dcterms:created>
  <dcterms:modified xsi:type="dcterms:W3CDTF">2022-04-20T16:28:48Z</dcterms:modified>
</cp:coreProperties>
</file>